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371722-AFAA-49B9-930A-97684F08160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735A84-F1F1-4516-9F17-842913FC12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A830E-095D-42FC-B1C8-5A61E2DC9F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E47487-F460-4AF8-8676-D3CCACF4473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D79A70-8634-447F-AB89-9CCC8D82B7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1DC40F-BFCC-4ED0-AC77-50C2BABA86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A42F73-4F7D-4103-B177-1B12C52926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D99BAA-D069-4750-91EB-AE4C51621A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340EA2-C570-400D-AD2E-AC6DA86EC9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F51259-EA09-46BF-AAA1-9B6CB45B24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466ADB-D885-46EA-BBD7-8596196395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BED6E6-930B-43D5-A7F9-7196699C05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17554E-7994-4C7D-80D8-BBEF42E6AFA4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tretch/>
        </p:blipFill>
        <p:spPr>
          <a:xfrm>
            <a:off x="1392120" y="857160"/>
            <a:ext cx="5965920" cy="384804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5"/>
          <p:cNvSpPr/>
          <p:nvPr/>
        </p:nvSpPr>
        <p:spPr>
          <a:xfrm>
            <a:off x="714240" y="4717080"/>
            <a:ext cx="77868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Figure S3.  TLR2 and TLR3 are not needed by PBP2 to induce DC maturation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Phenotypical analysis of WT, TLR2-/- and TLR3-/- DCs was performed upon PBP2 treatment and compared to untreated cells. Numbers in the dot plots represent the percentage of events in each quadrant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20T18:57:37Z</dcterms:created>
  <dc:creator>NAT_2010</dc:creator>
  <dc:description/>
  <dc:language>en-US</dc:language>
  <cp:lastModifiedBy> </cp:lastModifiedBy>
  <dcterms:modified xsi:type="dcterms:W3CDTF">2011-09-26T14:18:32Z</dcterms:modified>
  <cp:revision>2</cp:revision>
  <dc:subject/>
  <dc:title>Diapositive 1</dc:title>
</cp:coreProperties>
</file>